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7956550" cy="133556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06">
          <p15:clr>
            <a:srgbClr val="A4A3A4"/>
          </p15:clr>
        </p15:guide>
        <p15:guide id="2" pos="250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47" autoAdjust="0"/>
    <p:restoredTop sz="94660"/>
  </p:normalViewPr>
  <p:slideViewPr>
    <p:cSldViewPr snapToGrid="0">
      <p:cViewPr>
        <p:scale>
          <a:sx n="140" d="100"/>
          <a:sy n="140" d="100"/>
        </p:scale>
        <p:origin x="1128" y="80"/>
      </p:cViewPr>
      <p:guideLst>
        <p:guide orient="horz" pos="4206"/>
        <p:guide pos="25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6741" y="2185750"/>
            <a:ext cx="6763068" cy="4649741"/>
          </a:xfrm>
        </p:spPr>
        <p:txBody>
          <a:bodyPr anchor="b"/>
          <a:lstStyle>
            <a:lvl1pPr algn="ctr">
              <a:defRPr sz="5221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4569" y="7014802"/>
            <a:ext cx="5967413" cy="3224520"/>
          </a:xfrm>
        </p:spPr>
        <p:txBody>
          <a:bodyPr/>
          <a:lstStyle>
            <a:lvl1pPr marL="0" indent="0" algn="ctr">
              <a:buNone/>
              <a:defRPr sz="2088"/>
            </a:lvl1pPr>
            <a:lvl2pPr marL="397810" indent="0" algn="ctr">
              <a:buNone/>
              <a:defRPr sz="1740"/>
            </a:lvl2pPr>
            <a:lvl3pPr marL="795619" indent="0" algn="ctr">
              <a:buNone/>
              <a:defRPr sz="1566"/>
            </a:lvl3pPr>
            <a:lvl4pPr marL="1193429" indent="0" algn="ctr">
              <a:buNone/>
              <a:defRPr sz="1392"/>
            </a:lvl4pPr>
            <a:lvl5pPr marL="1591239" indent="0" algn="ctr">
              <a:buNone/>
              <a:defRPr sz="1392"/>
            </a:lvl5pPr>
            <a:lvl6pPr marL="1989049" indent="0" algn="ctr">
              <a:buNone/>
              <a:defRPr sz="1392"/>
            </a:lvl6pPr>
            <a:lvl7pPr marL="2386858" indent="0" algn="ctr">
              <a:buNone/>
              <a:defRPr sz="1392"/>
            </a:lvl7pPr>
            <a:lvl8pPr marL="2784668" indent="0" algn="ctr">
              <a:buNone/>
              <a:defRPr sz="1392"/>
            </a:lvl8pPr>
            <a:lvl9pPr marL="3182478" indent="0" algn="ctr">
              <a:buNone/>
              <a:defRPr sz="1392"/>
            </a:lvl9pPr>
          </a:lstStyle>
          <a:p>
            <a:r>
              <a:rPr lang="nl-NL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96371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36299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93907" y="711064"/>
            <a:ext cx="1715631" cy="11318286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7013" y="711064"/>
            <a:ext cx="5047436" cy="11318286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51442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07888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2869" y="3329639"/>
            <a:ext cx="6862524" cy="5555573"/>
          </a:xfrm>
        </p:spPr>
        <p:txBody>
          <a:bodyPr anchor="b"/>
          <a:lstStyle>
            <a:lvl1pPr>
              <a:defRPr sz="5221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2869" y="8937770"/>
            <a:ext cx="6862524" cy="2921545"/>
          </a:xfrm>
        </p:spPr>
        <p:txBody>
          <a:bodyPr/>
          <a:lstStyle>
            <a:lvl1pPr marL="0" indent="0">
              <a:buNone/>
              <a:defRPr sz="2088">
                <a:solidFill>
                  <a:schemeClr val="tx1"/>
                </a:solidFill>
              </a:defRPr>
            </a:lvl1pPr>
            <a:lvl2pPr marL="397810" indent="0">
              <a:buNone/>
              <a:defRPr sz="1740">
                <a:solidFill>
                  <a:schemeClr val="tx1">
                    <a:tint val="75000"/>
                  </a:schemeClr>
                </a:solidFill>
              </a:defRPr>
            </a:lvl2pPr>
            <a:lvl3pPr marL="795619" indent="0">
              <a:buNone/>
              <a:defRPr sz="1566">
                <a:solidFill>
                  <a:schemeClr val="tx1">
                    <a:tint val="75000"/>
                  </a:schemeClr>
                </a:solidFill>
              </a:defRPr>
            </a:lvl3pPr>
            <a:lvl4pPr marL="1193429" indent="0">
              <a:buNone/>
              <a:defRPr sz="1392">
                <a:solidFill>
                  <a:schemeClr val="tx1">
                    <a:tint val="75000"/>
                  </a:schemeClr>
                </a:solidFill>
              </a:defRPr>
            </a:lvl4pPr>
            <a:lvl5pPr marL="1591239" indent="0">
              <a:buNone/>
              <a:defRPr sz="1392">
                <a:solidFill>
                  <a:schemeClr val="tx1">
                    <a:tint val="75000"/>
                  </a:schemeClr>
                </a:solidFill>
              </a:defRPr>
            </a:lvl5pPr>
            <a:lvl6pPr marL="1989049" indent="0">
              <a:buNone/>
              <a:defRPr sz="1392">
                <a:solidFill>
                  <a:schemeClr val="tx1">
                    <a:tint val="75000"/>
                  </a:schemeClr>
                </a:solidFill>
              </a:defRPr>
            </a:lvl6pPr>
            <a:lvl7pPr marL="2386858" indent="0">
              <a:buNone/>
              <a:defRPr sz="1392">
                <a:solidFill>
                  <a:schemeClr val="tx1">
                    <a:tint val="75000"/>
                  </a:schemeClr>
                </a:solidFill>
              </a:defRPr>
            </a:lvl7pPr>
            <a:lvl8pPr marL="2784668" indent="0">
              <a:buNone/>
              <a:defRPr sz="1392">
                <a:solidFill>
                  <a:schemeClr val="tx1">
                    <a:tint val="75000"/>
                  </a:schemeClr>
                </a:solidFill>
              </a:defRPr>
            </a:lvl8pPr>
            <a:lvl9pPr marL="3182478" indent="0">
              <a:buNone/>
              <a:defRPr sz="13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50086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7013" y="3555320"/>
            <a:ext cx="3381534" cy="8474030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28003" y="3555320"/>
            <a:ext cx="3381534" cy="8474030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98186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049" y="711067"/>
            <a:ext cx="6862524" cy="2581473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050" y="3273987"/>
            <a:ext cx="3365993" cy="1604531"/>
          </a:xfrm>
        </p:spPr>
        <p:txBody>
          <a:bodyPr anchor="b"/>
          <a:lstStyle>
            <a:lvl1pPr marL="0" indent="0">
              <a:buNone/>
              <a:defRPr sz="2088" b="1"/>
            </a:lvl1pPr>
            <a:lvl2pPr marL="397810" indent="0">
              <a:buNone/>
              <a:defRPr sz="1740" b="1"/>
            </a:lvl2pPr>
            <a:lvl3pPr marL="795619" indent="0">
              <a:buNone/>
              <a:defRPr sz="1566" b="1"/>
            </a:lvl3pPr>
            <a:lvl4pPr marL="1193429" indent="0">
              <a:buNone/>
              <a:defRPr sz="1392" b="1"/>
            </a:lvl4pPr>
            <a:lvl5pPr marL="1591239" indent="0">
              <a:buNone/>
              <a:defRPr sz="1392" b="1"/>
            </a:lvl5pPr>
            <a:lvl6pPr marL="1989049" indent="0">
              <a:buNone/>
              <a:defRPr sz="1392" b="1"/>
            </a:lvl6pPr>
            <a:lvl7pPr marL="2386858" indent="0">
              <a:buNone/>
              <a:defRPr sz="1392" b="1"/>
            </a:lvl7pPr>
            <a:lvl8pPr marL="2784668" indent="0">
              <a:buNone/>
              <a:defRPr sz="1392" b="1"/>
            </a:lvl8pPr>
            <a:lvl9pPr marL="3182478" indent="0">
              <a:buNone/>
              <a:defRPr sz="1392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8050" y="4878518"/>
            <a:ext cx="3365993" cy="7175565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28004" y="3273987"/>
            <a:ext cx="3382570" cy="1604531"/>
          </a:xfrm>
        </p:spPr>
        <p:txBody>
          <a:bodyPr anchor="b"/>
          <a:lstStyle>
            <a:lvl1pPr marL="0" indent="0">
              <a:buNone/>
              <a:defRPr sz="2088" b="1"/>
            </a:lvl1pPr>
            <a:lvl2pPr marL="397810" indent="0">
              <a:buNone/>
              <a:defRPr sz="1740" b="1"/>
            </a:lvl2pPr>
            <a:lvl3pPr marL="795619" indent="0">
              <a:buNone/>
              <a:defRPr sz="1566" b="1"/>
            </a:lvl3pPr>
            <a:lvl4pPr marL="1193429" indent="0">
              <a:buNone/>
              <a:defRPr sz="1392" b="1"/>
            </a:lvl4pPr>
            <a:lvl5pPr marL="1591239" indent="0">
              <a:buNone/>
              <a:defRPr sz="1392" b="1"/>
            </a:lvl5pPr>
            <a:lvl6pPr marL="1989049" indent="0">
              <a:buNone/>
              <a:defRPr sz="1392" b="1"/>
            </a:lvl6pPr>
            <a:lvl7pPr marL="2386858" indent="0">
              <a:buNone/>
              <a:defRPr sz="1392" b="1"/>
            </a:lvl7pPr>
            <a:lvl8pPr marL="2784668" indent="0">
              <a:buNone/>
              <a:defRPr sz="1392" b="1"/>
            </a:lvl8pPr>
            <a:lvl9pPr marL="3182478" indent="0">
              <a:buNone/>
              <a:defRPr sz="1392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28004" y="4878518"/>
            <a:ext cx="3382570" cy="7175565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15585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33831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06352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049" y="890376"/>
            <a:ext cx="2566194" cy="3116316"/>
          </a:xfrm>
        </p:spPr>
        <p:txBody>
          <a:bodyPr anchor="b"/>
          <a:lstStyle>
            <a:lvl1pPr>
              <a:defRPr sz="2784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82570" y="1922968"/>
            <a:ext cx="4028003" cy="9491159"/>
          </a:xfrm>
        </p:spPr>
        <p:txBody>
          <a:bodyPr/>
          <a:lstStyle>
            <a:lvl1pPr>
              <a:defRPr sz="2784"/>
            </a:lvl1pPr>
            <a:lvl2pPr>
              <a:defRPr sz="2436"/>
            </a:lvl2pPr>
            <a:lvl3pPr>
              <a:defRPr sz="2088"/>
            </a:lvl3pPr>
            <a:lvl4pPr>
              <a:defRPr sz="1740"/>
            </a:lvl4pPr>
            <a:lvl5pPr>
              <a:defRPr sz="1740"/>
            </a:lvl5pPr>
            <a:lvl6pPr>
              <a:defRPr sz="1740"/>
            </a:lvl6pPr>
            <a:lvl7pPr>
              <a:defRPr sz="1740"/>
            </a:lvl7pPr>
            <a:lvl8pPr>
              <a:defRPr sz="1740"/>
            </a:lvl8pPr>
            <a:lvl9pPr>
              <a:defRPr sz="174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8049" y="4006692"/>
            <a:ext cx="2566194" cy="7422891"/>
          </a:xfrm>
        </p:spPr>
        <p:txBody>
          <a:bodyPr/>
          <a:lstStyle>
            <a:lvl1pPr marL="0" indent="0">
              <a:buNone/>
              <a:defRPr sz="1392"/>
            </a:lvl1pPr>
            <a:lvl2pPr marL="397810" indent="0">
              <a:buNone/>
              <a:defRPr sz="1218"/>
            </a:lvl2pPr>
            <a:lvl3pPr marL="795619" indent="0">
              <a:buNone/>
              <a:defRPr sz="1044"/>
            </a:lvl3pPr>
            <a:lvl4pPr marL="1193429" indent="0">
              <a:buNone/>
              <a:defRPr sz="870"/>
            </a:lvl4pPr>
            <a:lvl5pPr marL="1591239" indent="0">
              <a:buNone/>
              <a:defRPr sz="870"/>
            </a:lvl5pPr>
            <a:lvl6pPr marL="1989049" indent="0">
              <a:buNone/>
              <a:defRPr sz="870"/>
            </a:lvl6pPr>
            <a:lvl7pPr marL="2386858" indent="0">
              <a:buNone/>
              <a:defRPr sz="870"/>
            </a:lvl7pPr>
            <a:lvl8pPr marL="2784668" indent="0">
              <a:buNone/>
              <a:defRPr sz="870"/>
            </a:lvl8pPr>
            <a:lvl9pPr marL="3182478" indent="0">
              <a:buNone/>
              <a:defRPr sz="87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7282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049" y="890376"/>
            <a:ext cx="2566194" cy="3116316"/>
          </a:xfrm>
        </p:spPr>
        <p:txBody>
          <a:bodyPr anchor="b"/>
          <a:lstStyle>
            <a:lvl1pPr>
              <a:defRPr sz="2784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82570" y="1922968"/>
            <a:ext cx="4028003" cy="9491159"/>
          </a:xfrm>
        </p:spPr>
        <p:txBody>
          <a:bodyPr anchor="t"/>
          <a:lstStyle>
            <a:lvl1pPr marL="0" indent="0">
              <a:buNone/>
              <a:defRPr sz="2784"/>
            </a:lvl1pPr>
            <a:lvl2pPr marL="397810" indent="0">
              <a:buNone/>
              <a:defRPr sz="2436"/>
            </a:lvl2pPr>
            <a:lvl3pPr marL="795619" indent="0">
              <a:buNone/>
              <a:defRPr sz="2088"/>
            </a:lvl3pPr>
            <a:lvl4pPr marL="1193429" indent="0">
              <a:buNone/>
              <a:defRPr sz="1740"/>
            </a:lvl4pPr>
            <a:lvl5pPr marL="1591239" indent="0">
              <a:buNone/>
              <a:defRPr sz="1740"/>
            </a:lvl5pPr>
            <a:lvl6pPr marL="1989049" indent="0">
              <a:buNone/>
              <a:defRPr sz="1740"/>
            </a:lvl6pPr>
            <a:lvl7pPr marL="2386858" indent="0">
              <a:buNone/>
              <a:defRPr sz="1740"/>
            </a:lvl7pPr>
            <a:lvl8pPr marL="2784668" indent="0">
              <a:buNone/>
              <a:defRPr sz="1740"/>
            </a:lvl8pPr>
            <a:lvl9pPr marL="3182478" indent="0">
              <a:buNone/>
              <a:defRPr sz="1740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8049" y="4006692"/>
            <a:ext cx="2566194" cy="7422891"/>
          </a:xfrm>
        </p:spPr>
        <p:txBody>
          <a:bodyPr/>
          <a:lstStyle>
            <a:lvl1pPr marL="0" indent="0">
              <a:buNone/>
              <a:defRPr sz="1392"/>
            </a:lvl1pPr>
            <a:lvl2pPr marL="397810" indent="0">
              <a:buNone/>
              <a:defRPr sz="1218"/>
            </a:lvl2pPr>
            <a:lvl3pPr marL="795619" indent="0">
              <a:buNone/>
              <a:defRPr sz="1044"/>
            </a:lvl3pPr>
            <a:lvl4pPr marL="1193429" indent="0">
              <a:buNone/>
              <a:defRPr sz="870"/>
            </a:lvl4pPr>
            <a:lvl5pPr marL="1591239" indent="0">
              <a:buNone/>
              <a:defRPr sz="870"/>
            </a:lvl5pPr>
            <a:lvl6pPr marL="1989049" indent="0">
              <a:buNone/>
              <a:defRPr sz="870"/>
            </a:lvl6pPr>
            <a:lvl7pPr marL="2386858" indent="0">
              <a:buNone/>
              <a:defRPr sz="870"/>
            </a:lvl7pPr>
            <a:lvl8pPr marL="2784668" indent="0">
              <a:buNone/>
              <a:defRPr sz="870"/>
            </a:lvl8pPr>
            <a:lvl9pPr marL="3182478" indent="0">
              <a:buNone/>
              <a:defRPr sz="87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5274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7013" y="711067"/>
            <a:ext cx="6862524" cy="258147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7013" y="3555320"/>
            <a:ext cx="6862524" cy="84740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7013" y="12378701"/>
            <a:ext cx="1790224" cy="71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5333D0-41A5-493F-A0DC-BA15AC9DF63E}" type="datetimeFigureOut">
              <a:rPr lang="nl-NL" smtClean="0"/>
              <a:t>01-04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35607" y="12378701"/>
            <a:ext cx="2685336" cy="71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619313" y="12378701"/>
            <a:ext cx="1790224" cy="71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D11B67-BB08-4F73-BE52-3A3BF407E32E}" type="slidenum">
              <a:rPr lang="nl-NL" smtClean="0"/>
              <a:t>‹nº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38983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95619" rtl="0" eaLnBrk="1" latinLnBrk="0" hangingPunct="1">
        <a:lnSpc>
          <a:spcPct val="90000"/>
        </a:lnSpc>
        <a:spcBef>
          <a:spcPct val="0"/>
        </a:spcBef>
        <a:buNone/>
        <a:defRPr sz="382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8905" indent="-198905" algn="l" defTabSz="795619" rtl="0" eaLnBrk="1" latinLnBrk="0" hangingPunct="1">
        <a:lnSpc>
          <a:spcPct val="90000"/>
        </a:lnSpc>
        <a:spcBef>
          <a:spcPts val="870"/>
        </a:spcBef>
        <a:buFont typeface="Arial" panose="020B0604020202020204" pitchFamily="34" charset="0"/>
        <a:buChar char="•"/>
        <a:defRPr sz="2436" kern="1200">
          <a:solidFill>
            <a:schemeClr val="tx1"/>
          </a:solidFill>
          <a:latin typeface="+mn-lt"/>
          <a:ea typeface="+mn-ea"/>
          <a:cs typeface="+mn-cs"/>
        </a:defRPr>
      </a:lvl1pPr>
      <a:lvl2pPr marL="596715" indent="-198905" algn="l" defTabSz="795619" rtl="0" eaLnBrk="1" latinLnBrk="0" hangingPunct="1">
        <a:lnSpc>
          <a:spcPct val="90000"/>
        </a:lnSpc>
        <a:spcBef>
          <a:spcPts val="435"/>
        </a:spcBef>
        <a:buFont typeface="Arial" panose="020B0604020202020204" pitchFamily="34" charset="0"/>
        <a:buChar char="•"/>
        <a:defRPr sz="2088" kern="1200">
          <a:solidFill>
            <a:schemeClr val="tx1"/>
          </a:solidFill>
          <a:latin typeface="+mn-lt"/>
          <a:ea typeface="+mn-ea"/>
          <a:cs typeface="+mn-cs"/>
        </a:defRPr>
      </a:lvl2pPr>
      <a:lvl3pPr marL="994524" indent="-198905" algn="l" defTabSz="795619" rtl="0" eaLnBrk="1" latinLnBrk="0" hangingPunct="1">
        <a:lnSpc>
          <a:spcPct val="90000"/>
        </a:lnSpc>
        <a:spcBef>
          <a:spcPts val="435"/>
        </a:spcBef>
        <a:buFont typeface="Arial" panose="020B0604020202020204" pitchFamily="34" charset="0"/>
        <a:buChar char="•"/>
        <a:defRPr sz="1740" kern="1200">
          <a:solidFill>
            <a:schemeClr val="tx1"/>
          </a:solidFill>
          <a:latin typeface="+mn-lt"/>
          <a:ea typeface="+mn-ea"/>
          <a:cs typeface="+mn-cs"/>
        </a:defRPr>
      </a:lvl3pPr>
      <a:lvl4pPr marL="1392334" indent="-198905" algn="l" defTabSz="795619" rtl="0" eaLnBrk="1" latinLnBrk="0" hangingPunct="1">
        <a:lnSpc>
          <a:spcPct val="90000"/>
        </a:lnSpc>
        <a:spcBef>
          <a:spcPts val="435"/>
        </a:spcBef>
        <a:buFont typeface="Arial" panose="020B0604020202020204" pitchFamily="34" charset="0"/>
        <a:buChar char="•"/>
        <a:defRPr sz="1566" kern="1200">
          <a:solidFill>
            <a:schemeClr val="tx1"/>
          </a:solidFill>
          <a:latin typeface="+mn-lt"/>
          <a:ea typeface="+mn-ea"/>
          <a:cs typeface="+mn-cs"/>
        </a:defRPr>
      </a:lvl4pPr>
      <a:lvl5pPr marL="1790144" indent="-198905" algn="l" defTabSz="795619" rtl="0" eaLnBrk="1" latinLnBrk="0" hangingPunct="1">
        <a:lnSpc>
          <a:spcPct val="90000"/>
        </a:lnSpc>
        <a:spcBef>
          <a:spcPts val="435"/>
        </a:spcBef>
        <a:buFont typeface="Arial" panose="020B0604020202020204" pitchFamily="34" charset="0"/>
        <a:buChar char="•"/>
        <a:defRPr sz="1566" kern="1200">
          <a:solidFill>
            <a:schemeClr val="tx1"/>
          </a:solidFill>
          <a:latin typeface="+mn-lt"/>
          <a:ea typeface="+mn-ea"/>
          <a:cs typeface="+mn-cs"/>
        </a:defRPr>
      </a:lvl5pPr>
      <a:lvl6pPr marL="2187953" indent="-198905" algn="l" defTabSz="795619" rtl="0" eaLnBrk="1" latinLnBrk="0" hangingPunct="1">
        <a:lnSpc>
          <a:spcPct val="90000"/>
        </a:lnSpc>
        <a:spcBef>
          <a:spcPts val="435"/>
        </a:spcBef>
        <a:buFont typeface="Arial" panose="020B0604020202020204" pitchFamily="34" charset="0"/>
        <a:buChar char="•"/>
        <a:defRPr sz="1566" kern="1200">
          <a:solidFill>
            <a:schemeClr val="tx1"/>
          </a:solidFill>
          <a:latin typeface="+mn-lt"/>
          <a:ea typeface="+mn-ea"/>
          <a:cs typeface="+mn-cs"/>
        </a:defRPr>
      </a:lvl6pPr>
      <a:lvl7pPr marL="2585763" indent="-198905" algn="l" defTabSz="795619" rtl="0" eaLnBrk="1" latinLnBrk="0" hangingPunct="1">
        <a:lnSpc>
          <a:spcPct val="90000"/>
        </a:lnSpc>
        <a:spcBef>
          <a:spcPts val="435"/>
        </a:spcBef>
        <a:buFont typeface="Arial" panose="020B0604020202020204" pitchFamily="34" charset="0"/>
        <a:buChar char="•"/>
        <a:defRPr sz="1566" kern="1200">
          <a:solidFill>
            <a:schemeClr val="tx1"/>
          </a:solidFill>
          <a:latin typeface="+mn-lt"/>
          <a:ea typeface="+mn-ea"/>
          <a:cs typeface="+mn-cs"/>
        </a:defRPr>
      </a:lvl7pPr>
      <a:lvl8pPr marL="2983573" indent="-198905" algn="l" defTabSz="795619" rtl="0" eaLnBrk="1" latinLnBrk="0" hangingPunct="1">
        <a:lnSpc>
          <a:spcPct val="90000"/>
        </a:lnSpc>
        <a:spcBef>
          <a:spcPts val="435"/>
        </a:spcBef>
        <a:buFont typeface="Arial" panose="020B0604020202020204" pitchFamily="34" charset="0"/>
        <a:buChar char="•"/>
        <a:defRPr sz="1566" kern="1200">
          <a:solidFill>
            <a:schemeClr val="tx1"/>
          </a:solidFill>
          <a:latin typeface="+mn-lt"/>
          <a:ea typeface="+mn-ea"/>
          <a:cs typeface="+mn-cs"/>
        </a:defRPr>
      </a:lvl8pPr>
      <a:lvl9pPr marL="3381383" indent="-198905" algn="l" defTabSz="795619" rtl="0" eaLnBrk="1" latinLnBrk="0" hangingPunct="1">
        <a:lnSpc>
          <a:spcPct val="90000"/>
        </a:lnSpc>
        <a:spcBef>
          <a:spcPts val="435"/>
        </a:spcBef>
        <a:buFont typeface="Arial" panose="020B0604020202020204" pitchFamily="34" charset="0"/>
        <a:buChar char="•"/>
        <a:defRPr sz="156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5619" rtl="0" eaLnBrk="1" latinLnBrk="0" hangingPunct="1">
        <a:defRPr sz="1566" kern="1200">
          <a:solidFill>
            <a:schemeClr val="tx1"/>
          </a:solidFill>
          <a:latin typeface="+mn-lt"/>
          <a:ea typeface="+mn-ea"/>
          <a:cs typeface="+mn-cs"/>
        </a:defRPr>
      </a:lvl1pPr>
      <a:lvl2pPr marL="397810" algn="l" defTabSz="795619" rtl="0" eaLnBrk="1" latinLnBrk="0" hangingPunct="1">
        <a:defRPr sz="1566" kern="1200">
          <a:solidFill>
            <a:schemeClr val="tx1"/>
          </a:solidFill>
          <a:latin typeface="+mn-lt"/>
          <a:ea typeface="+mn-ea"/>
          <a:cs typeface="+mn-cs"/>
        </a:defRPr>
      </a:lvl2pPr>
      <a:lvl3pPr marL="795619" algn="l" defTabSz="795619" rtl="0" eaLnBrk="1" latinLnBrk="0" hangingPunct="1">
        <a:defRPr sz="1566" kern="1200">
          <a:solidFill>
            <a:schemeClr val="tx1"/>
          </a:solidFill>
          <a:latin typeface="+mn-lt"/>
          <a:ea typeface="+mn-ea"/>
          <a:cs typeface="+mn-cs"/>
        </a:defRPr>
      </a:lvl3pPr>
      <a:lvl4pPr marL="1193429" algn="l" defTabSz="795619" rtl="0" eaLnBrk="1" latinLnBrk="0" hangingPunct="1">
        <a:defRPr sz="1566" kern="1200">
          <a:solidFill>
            <a:schemeClr val="tx1"/>
          </a:solidFill>
          <a:latin typeface="+mn-lt"/>
          <a:ea typeface="+mn-ea"/>
          <a:cs typeface="+mn-cs"/>
        </a:defRPr>
      </a:lvl4pPr>
      <a:lvl5pPr marL="1591239" algn="l" defTabSz="795619" rtl="0" eaLnBrk="1" latinLnBrk="0" hangingPunct="1">
        <a:defRPr sz="1566" kern="1200">
          <a:solidFill>
            <a:schemeClr val="tx1"/>
          </a:solidFill>
          <a:latin typeface="+mn-lt"/>
          <a:ea typeface="+mn-ea"/>
          <a:cs typeface="+mn-cs"/>
        </a:defRPr>
      </a:lvl5pPr>
      <a:lvl6pPr marL="1989049" algn="l" defTabSz="795619" rtl="0" eaLnBrk="1" latinLnBrk="0" hangingPunct="1">
        <a:defRPr sz="1566" kern="1200">
          <a:solidFill>
            <a:schemeClr val="tx1"/>
          </a:solidFill>
          <a:latin typeface="+mn-lt"/>
          <a:ea typeface="+mn-ea"/>
          <a:cs typeface="+mn-cs"/>
        </a:defRPr>
      </a:lvl6pPr>
      <a:lvl7pPr marL="2386858" algn="l" defTabSz="795619" rtl="0" eaLnBrk="1" latinLnBrk="0" hangingPunct="1">
        <a:defRPr sz="1566" kern="1200">
          <a:solidFill>
            <a:schemeClr val="tx1"/>
          </a:solidFill>
          <a:latin typeface="+mn-lt"/>
          <a:ea typeface="+mn-ea"/>
          <a:cs typeface="+mn-cs"/>
        </a:defRPr>
      </a:lvl7pPr>
      <a:lvl8pPr marL="2784668" algn="l" defTabSz="795619" rtl="0" eaLnBrk="1" latinLnBrk="0" hangingPunct="1">
        <a:defRPr sz="1566" kern="1200">
          <a:solidFill>
            <a:schemeClr val="tx1"/>
          </a:solidFill>
          <a:latin typeface="+mn-lt"/>
          <a:ea typeface="+mn-ea"/>
          <a:cs typeface="+mn-cs"/>
        </a:defRPr>
      </a:lvl8pPr>
      <a:lvl9pPr marL="3182478" algn="l" defTabSz="795619" rtl="0" eaLnBrk="1" latinLnBrk="0" hangingPunct="1">
        <a:defRPr sz="156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0" name="Tabel 5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3238135"/>
              </p:ext>
            </p:extLst>
          </p:nvPr>
        </p:nvGraphicFramePr>
        <p:xfrm>
          <a:off x="2517811" y="27255"/>
          <a:ext cx="5358861" cy="132188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8726">
                  <a:extLst>
                    <a:ext uri="{9D8B030D-6E8A-4147-A177-3AD203B41FA5}">
                      <a16:colId xmlns:a16="http://schemas.microsoft.com/office/drawing/2014/main" val="3610672786"/>
                    </a:ext>
                  </a:extLst>
                </a:gridCol>
                <a:gridCol w="228726">
                  <a:extLst>
                    <a:ext uri="{9D8B030D-6E8A-4147-A177-3AD203B41FA5}">
                      <a16:colId xmlns:a16="http://schemas.microsoft.com/office/drawing/2014/main" val="1801285611"/>
                    </a:ext>
                  </a:extLst>
                </a:gridCol>
                <a:gridCol w="228726">
                  <a:extLst>
                    <a:ext uri="{9D8B030D-6E8A-4147-A177-3AD203B41FA5}">
                      <a16:colId xmlns:a16="http://schemas.microsoft.com/office/drawing/2014/main" val="3714522663"/>
                    </a:ext>
                  </a:extLst>
                </a:gridCol>
                <a:gridCol w="34709">
                  <a:extLst>
                    <a:ext uri="{9D8B030D-6E8A-4147-A177-3AD203B41FA5}">
                      <a16:colId xmlns:a16="http://schemas.microsoft.com/office/drawing/2014/main" val="3372667920"/>
                    </a:ext>
                  </a:extLst>
                </a:gridCol>
                <a:gridCol w="228726">
                  <a:extLst>
                    <a:ext uri="{9D8B030D-6E8A-4147-A177-3AD203B41FA5}">
                      <a16:colId xmlns:a16="http://schemas.microsoft.com/office/drawing/2014/main" val="217629281"/>
                    </a:ext>
                  </a:extLst>
                </a:gridCol>
                <a:gridCol w="228726">
                  <a:extLst>
                    <a:ext uri="{9D8B030D-6E8A-4147-A177-3AD203B41FA5}">
                      <a16:colId xmlns:a16="http://schemas.microsoft.com/office/drawing/2014/main" val="3800426423"/>
                    </a:ext>
                  </a:extLst>
                </a:gridCol>
                <a:gridCol w="228726">
                  <a:extLst>
                    <a:ext uri="{9D8B030D-6E8A-4147-A177-3AD203B41FA5}">
                      <a16:colId xmlns:a16="http://schemas.microsoft.com/office/drawing/2014/main" val="2518556569"/>
                    </a:ext>
                  </a:extLst>
                </a:gridCol>
                <a:gridCol w="34709">
                  <a:extLst>
                    <a:ext uri="{9D8B030D-6E8A-4147-A177-3AD203B41FA5}">
                      <a16:colId xmlns:a16="http://schemas.microsoft.com/office/drawing/2014/main" val="592378593"/>
                    </a:ext>
                  </a:extLst>
                </a:gridCol>
                <a:gridCol w="228726">
                  <a:extLst>
                    <a:ext uri="{9D8B030D-6E8A-4147-A177-3AD203B41FA5}">
                      <a16:colId xmlns:a16="http://schemas.microsoft.com/office/drawing/2014/main" val="2297706782"/>
                    </a:ext>
                  </a:extLst>
                </a:gridCol>
                <a:gridCol w="228726">
                  <a:extLst>
                    <a:ext uri="{9D8B030D-6E8A-4147-A177-3AD203B41FA5}">
                      <a16:colId xmlns:a16="http://schemas.microsoft.com/office/drawing/2014/main" val="1818906225"/>
                    </a:ext>
                  </a:extLst>
                </a:gridCol>
                <a:gridCol w="228726">
                  <a:extLst>
                    <a:ext uri="{9D8B030D-6E8A-4147-A177-3AD203B41FA5}">
                      <a16:colId xmlns:a16="http://schemas.microsoft.com/office/drawing/2014/main" val="3050204874"/>
                    </a:ext>
                  </a:extLst>
                </a:gridCol>
                <a:gridCol w="34709">
                  <a:extLst>
                    <a:ext uri="{9D8B030D-6E8A-4147-A177-3AD203B41FA5}">
                      <a16:colId xmlns:a16="http://schemas.microsoft.com/office/drawing/2014/main" val="2961394142"/>
                    </a:ext>
                  </a:extLst>
                </a:gridCol>
                <a:gridCol w="228726">
                  <a:extLst>
                    <a:ext uri="{9D8B030D-6E8A-4147-A177-3AD203B41FA5}">
                      <a16:colId xmlns:a16="http://schemas.microsoft.com/office/drawing/2014/main" val="3912643054"/>
                    </a:ext>
                  </a:extLst>
                </a:gridCol>
                <a:gridCol w="228726">
                  <a:extLst>
                    <a:ext uri="{9D8B030D-6E8A-4147-A177-3AD203B41FA5}">
                      <a16:colId xmlns:a16="http://schemas.microsoft.com/office/drawing/2014/main" val="118635635"/>
                    </a:ext>
                  </a:extLst>
                </a:gridCol>
                <a:gridCol w="228726">
                  <a:extLst>
                    <a:ext uri="{9D8B030D-6E8A-4147-A177-3AD203B41FA5}">
                      <a16:colId xmlns:a16="http://schemas.microsoft.com/office/drawing/2014/main" val="93921665"/>
                    </a:ext>
                  </a:extLst>
                </a:gridCol>
                <a:gridCol w="34709">
                  <a:extLst>
                    <a:ext uri="{9D8B030D-6E8A-4147-A177-3AD203B41FA5}">
                      <a16:colId xmlns:a16="http://schemas.microsoft.com/office/drawing/2014/main" val="4162492725"/>
                    </a:ext>
                  </a:extLst>
                </a:gridCol>
                <a:gridCol w="666701">
                  <a:extLst>
                    <a:ext uri="{9D8B030D-6E8A-4147-A177-3AD203B41FA5}">
                      <a16:colId xmlns:a16="http://schemas.microsoft.com/office/drawing/2014/main" val="2110971355"/>
                    </a:ext>
                  </a:extLst>
                </a:gridCol>
                <a:gridCol w="34709">
                  <a:extLst>
                    <a:ext uri="{9D8B030D-6E8A-4147-A177-3AD203B41FA5}">
                      <a16:colId xmlns:a16="http://schemas.microsoft.com/office/drawing/2014/main" val="2033975876"/>
                    </a:ext>
                  </a:extLst>
                </a:gridCol>
                <a:gridCol w="658024">
                  <a:extLst>
                    <a:ext uri="{9D8B030D-6E8A-4147-A177-3AD203B41FA5}">
                      <a16:colId xmlns:a16="http://schemas.microsoft.com/office/drawing/2014/main" val="1625781738"/>
                    </a:ext>
                  </a:extLst>
                </a:gridCol>
                <a:gridCol w="33375">
                  <a:extLst>
                    <a:ext uri="{9D8B030D-6E8A-4147-A177-3AD203B41FA5}">
                      <a16:colId xmlns:a16="http://schemas.microsoft.com/office/drawing/2014/main" val="2726467881"/>
                    </a:ext>
                  </a:extLst>
                </a:gridCol>
                <a:gridCol w="658024">
                  <a:extLst>
                    <a:ext uri="{9D8B030D-6E8A-4147-A177-3AD203B41FA5}">
                      <a16:colId xmlns:a16="http://schemas.microsoft.com/office/drawing/2014/main" val="2523670671"/>
                    </a:ext>
                  </a:extLst>
                </a:gridCol>
                <a:gridCol w="29667">
                  <a:extLst>
                    <a:ext uri="{9D8B030D-6E8A-4147-A177-3AD203B41FA5}">
                      <a16:colId xmlns:a16="http://schemas.microsoft.com/office/drawing/2014/main" val="1292266136"/>
                    </a:ext>
                  </a:extLst>
                </a:gridCol>
                <a:gridCol w="394813">
                  <a:extLst>
                    <a:ext uri="{9D8B030D-6E8A-4147-A177-3AD203B41FA5}">
                      <a16:colId xmlns:a16="http://schemas.microsoft.com/office/drawing/2014/main" val="541955441"/>
                    </a:ext>
                  </a:extLst>
                </a:gridCol>
              </a:tblGrid>
              <a:tr h="164511">
                <a:tc gridSpan="3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M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M3-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M3-I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M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ID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ospita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Country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Clade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8142203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b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c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381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a</a:t>
                      </a:r>
                    </a:p>
                  </a:txBody>
                  <a:tcPr marL="0" marR="0" marT="0" marB="0" anchor="ctr">
                    <a:lnL w="381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b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c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381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a</a:t>
                      </a:r>
                    </a:p>
                  </a:txBody>
                  <a:tcPr marL="0" marR="0" marT="0" marB="0" anchor="ctr">
                    <a:lnL w="381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b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c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381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a</a:t>
                      </a:r>
                    </a:p>
                  </a:txBody>
                  <a:tcPr marL="0" marR="0" marT="0" marB="0" anchor="ctr">
                    <a:lnL w="381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b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c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381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lang="nl-NL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441894380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4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4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0-05-15-5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South Afric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II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2636063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4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4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0-08-12-0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Spain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6713988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0-11-13-1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Indi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2821966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0-13-13-0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Kuwait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2851533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4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4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0-03-10-6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South Kore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I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2171421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4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0-03-10-6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Japan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0505541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WMB191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Singapore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V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795340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MDB121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Singapore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3623591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l880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Colombi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65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IV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5566162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l885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Colombi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0268230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lBOG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Colombi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7593922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l881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Colombi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6578807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l88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Colombi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2152594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55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TR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5797406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56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TR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4836123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84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TR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3233333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434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2883636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23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4983722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24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5806088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26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4762555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27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541099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28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749674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52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6085209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53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4883925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54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548745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11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TR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3847585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12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TR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6080480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269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TR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0177434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55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5012258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54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TR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2358357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51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9024389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38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6902049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39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4368764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42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8334424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44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6667599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45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8837790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47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2885708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48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0466908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49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6720715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51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8378474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60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638752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61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76764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63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3612337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64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3250194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46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0619147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50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6770569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62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1024178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388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4675418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67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895864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68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6228404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95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8295114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98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3329421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99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2180206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00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1448050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05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9951395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06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2571815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07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969241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12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4103785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04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0309379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96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9514328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08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1842387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387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3377146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389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2456366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403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0050121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427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6287155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428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R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4163507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1190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US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1493292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82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M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7551626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83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M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6303264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266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M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6339952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268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M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4209251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51/2023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M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3462351"/>
                  </a:ext>
                </a:extLst>
              </a:tr>
              <a:tr h="173858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5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3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32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5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43/2022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HMA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Brazil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7253532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8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-11-10-18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Iran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V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5470959"/>
                  </a:ext>
                </a:extLst>
              </a:tr>
              <a:tr h="164511"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9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4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2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11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-13-10-57</a:t>
                      </a: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000" dirty="0">
                          <a:solidFill>
                            <a:schemeClr val="tx1"/>
                          </a:solidFill>
                          <a:latin typeface="+mn-lt"/>
                        </a:rPr>
                        <a:t>Iran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nl-NL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1250015"/>
                  </a:ext>
                </a:extLst>
              </a:tr>
            </a:tbl>
          </a:graphicData>
        </a:graphic>
      </p:graphicFrame>
      <p:cxnSp>
        <p:nvCxnSpPr>
          <p:cNvPr id="62" name="Rechte verbindingslijn 61"/>
          <p:cNvCxnSpPr/>
          <p:nvPr/>
        </p:nvCxnSpPr>
        <p:spPr>
          <a:xfrm flipH="1">
            <a:off x="150838" y="337457"/>
            <a:ext cx="22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Rechte verbindingslijn 62"/>
          <p:cNvCxnSpPr/>
          <p:nvPr/>
        </p:nvCxnSpPr>
        <p:spPr>
          <a:xfrm>
            <a:off x="2378075" y="270220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Rechte verbindingslijn 63"/>
          <p:cNvCxnSpPr/>
          <p:nvPr/>
        </p:nvCxnSpPr>
        <p:spPr>
          <a:xfrm>
            <a:off x="1931675" y="270219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Rechte verbindingslijn 64"/>
          <p:cNvCxnSpPr/>
          <p:nvPr/>
        </p:nvCxnSpPr>
        <p:spPr>
          <a:xfrm>
            <a:off x="1485275" y="270219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Rechte verbindingslijn 65"/>
          <p:cNvCxnSpPr/>
          <p:nvPr/>
        </p:nvCxnSpPr>
        <p:spPr>
          <a:xfrm>
            <a:off x="1049328" y="270219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Rechte verbindingslijn 66"/>
          <p:cNvCxnSpPr/>
          <p:nvPr/>
        </p:nvCxnSpPr>
        <p:spPr>
          <a:xfrm>
            <a:off x="602928" y="270219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kstvak 67"/>
          <p:cNvSpPr txBox="1"/>
          <p:nvPr/>
        </p:nvSpPr>
        <p:spPr>
          <a:xfrm>
            <a:off x="68458" y="-62580"/>
            <a:ext cx="9364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100" dirty="0"/>
              <a:t>Similarity (%)</a:t>
            </a:r>
          </a:p>
        </p:txBody>
      </p:sp>
      <p:sp>
        <p:nvSpPr>
          <p:cNvPr id="69" name="Tekstvak 68"/>
          <p:cNvSpPr txBox="1"/>
          <p:nvPr/>
        </p:nvSpPr>
        <p:spPr>
          <a:xfrm>
            <a:off x="441361" y="6837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100" dirty="0"/>
              <a:t>20</a:t>
            </a:r>
          </a:p>
        </p:txBody>
      </p:sp>
      <p:sp>
        <p:nvSpPr>
          <p:cNvPr id="70" name="Tekstvak 69"/>
          <p:cNvSpPr txBox="1"/>
          <p:nvPr/>
        </p:nvSpPr>
        <p:spPr>
          <a:xfrm>
            <a:off x="886831" y="68704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100" dirty="0"/>
              <a:t>40</a:t>
            </a:r>
          </a:p>
        </p:txBody>
      </p:sp>
      <p:sp>
        <p:nvSpPr>
          <p:cNvPr id="71" name="Tekstvak 70"/>
          <p:cNvSpPr txBox="1"/>
          <p:nvPr/>
        </p:nvSpPr>
        <p:spPr>
          <a:xfrm>
            <a:off x="1320372" y="68698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100" dirty="0"/>
              <a:t>60</a:t>
            </a:r>
          </a:p>
        </p:txBody>
      </p:sp>
      <p:sp>
        <p:nvSpPr>
          <p:cNvPr id="72" name="Tekstvak 71"/>
          <p:cNvSpPr txBox="1"/>
          <p:nvPr/>
        </p:nvSpPr>
        <p:spPr>
          <a:xfrm>
            <a:off x="1767800" y="68698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100" dirty="0"/>
              <a:t>80</a:t>
            </a:r>
          </a:p>
        </p:txBody>
      </p:sp>
      <p:sp>
        <p:nvSpPr>
          <p:cNvPr id="73" name="Tekstvak 72"/>
          <p:cNvSpPr txBox="1"/>
          <p:nvPr/>
        </p:nvSpPr>
        <p:spPr>
          <a:xfrm>
            <a:off x="2164457" y="69894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100" dirty="0"/>
              <a:t>100</a:t>
            </a:r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 rotWithShape="1">
          <a:blip r:embed="rId2"/>
          <a:srcRect t="7866" r="41582" b="2805"/>
          <a:stretch/>
        </p:blipFill>
        <p:spPr>
          <a:xfrm>
            <a:off x="150838" y="350334"/>
            <a:ext cx="2335032" cy="1288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9404180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4</TotalTime>
  <Words>1144</Words>
  <Application>Microsoft Macintosh PowerPoint</Application>
  <PresentationFormat>Personalizar</PresentationFormat>
  <Paragraphs>114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Apresentação do PowerPoint</vt:lpstr>
    </vt:vector>
  </TitlesOfParts>
  <Company>CW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Bram Spruijtenburg</dc:creator>
  <cp:lastModifiedBy>Microsoft Office User</cp:lastModifiedBy>
  <cp:revision>4</cp:revision>
  <dcterms:created xsi:type="dcterms:W3CDTF">2025-04-01T14:05:14Z</dcterms:created>
  <dcterms:modified xsi:type="dcterms:W3CDTF">2025-04-02T12:53:56Z</dcterms:modified>
</cp:coreProperties>
</file>